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426" y="10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4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DE2911-B684-429D-B7E9-01CE20622E19}" type="datetimeFigureOut">
              <a:rPr lang="en-IN" smtClean="0"/>
              <a:t>10-06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BC5463-AFC1-45E8-A07C-50BDAA6E14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7990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BC5463-AFC1-45E8-A07C-50BDAA6E140D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62233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10" Type="http://schemas.openxmlformats.org/officeDocument/2006/relationships/image" Target="../media/image10.emf"/><Relationship Id="rId4" Type="http://schemas.openxmlformats.org/officeDocument/2006/relationships/image" Target="../media/image7.emf"/><Relationship Id="rId9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762000" y="2678668"/>
            <a:ext cx="9541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Eugeno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Rectangle 6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6777955" y="2023031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Galbacin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Rectangle 8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4765393" y="2826758"/>
            <a:ext cx="11464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Myristicin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193478" y="596576"/>
            <a:ext cx="3381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Identified constituents of MFA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Rectangle 10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4807177"/>
              </p:ext>
            </p:extLst>
          </p:nvPr>
        </p:nvGraphicFramePr>
        <p:xfrm>
          <a:off x="369886" y="2005139"/>
          <a:ext cx="1935163" cy="647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9" name="ChemSketch" r:id="rId4" imgW="1935551" imgH="647708" progId="ACD.ChemSketch.20">
                  <p:embed/>
                </p:oleObj>
              </mc:Choice>
              <mc:Fallback>
                <p:oleObj name="ChemSketch" r:id="rId4" imgW="1935551" imgH="647708" progId="ACD.ChemSketch.20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9886" y="2005139"/>
                        <a:ext cx="1935163" cy="6477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Rectangle 12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2499800"/>
              </p:ext>
            </p:extLst>
          </p:nvPr>
        </p:nvGraphicFramePr>
        <p:xfrm>
          <a:off x="2563017" y="1321356"/>
          <a:ext cx="1851025" cy="701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" name="ChemSketch" r:id="rId6" imgW="1844111" imgH="693333" progId="ACD.ChemSketch.20">
                  <p:embed/>
                </p:oleObj>
              </mc:Choice>
              <mc:Fallback>
                <p:oleObj name="ChemSketch" r:id="rId6" imgW="1844111" imgH="693333" progId="ACD.ChemSketch.20">
                  <p:embed/>
                  <p:pic>
                    <p:nvPicPr>
                      <p:cNvPr id="0" name="Object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63017" y="1321356"/>
                        <a:ext cx="1851025" cy="7016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Rectangle 14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8002072"/>
              </p:ext>
            </p:extLst>
          </p:nvPr>
        </p:nvGraphicFramePr>
        <p:xfrm>
          <a:off x="4690298" y="1699887"/>
          <a:ext cx="1744663" cy="1120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1" name="ChemSketch" r:id="rId8" imgW="1745015" imgH="1120164" progId="ACD.ChemSketch.20">
                  <p:embed/>
                </p:oleObj>
              </mc:Choice>
              <mc:Fallback>
                <p:oleObj name="ChemSketch" r:id="rId8" imgW="1745015" imgH="1120164" progId="ACD.ChemSketch.20">
                  <p:embed/>
                  <p:pic>
                    <p:nvPicPr>
                      <p:cNvPr id="0" name="Object 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90298" y="1699887"/>
                        <a:ext cx="1744663" cy="11207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Rectangle 16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0241653"/>
              </p:ext>
            </p:extLst>
          </p:nvPr>
        </p:nvGraphicFramePr>
        <p:xfrm>
          <a:off x="6272280" y="1150410"/>
          <a:ext cx="2544763" cy="121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2" name="ChemSketch" r:id="rId10" imgW="2545009" imgH="1219089" progId="ACD.ChemSketch.20">
                  <p:embed/>
                </p:oleObj>
              </mc:Choice>
              <mc:Fallback>
                <p:oleObj name="ChemSketch" r:id="rId10" imgW="2545009" imgH="1219089" progId="ACD.ChemSketch.20">
                  <p:embed/>
                  <p:pic>
                    <p:nvPicPr>
                      <p:cNvPr id="0" name="Object 1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272280" y="1150410"/>
                        <a:ext cx="2544763" cy="12192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Rectangle 23"/>
          <p:cNvSpPr/>
          <p:nvPr/>
        </p:nvSpPr>
        <p:spPr>
          <a:xfrm>
            <a:off x="2752513" y="2023031"/>
            <a:ext cx="16401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Methyl eugeno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Rectangle 18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5106892"/>
              </p:ext>
            </p:extLst>
          </p:nvPr>
        </p:nvGraphicFramePr>
        <p:xfrm>
          <a:off x="312057" y="3196090"/>
          <a:ext cx="2987675" cy="1736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3" name="ChemSketch" r:id="rId12" imgW="2987324" imgH="1737170" progId="ACD.ChemSketch.20">
                  <p:embed/>
                </p:oleObj>
              </mc:Choice>
              <mc:Fallback>
                <p:oleObj name="ChemSketch" r:id="rId12" imgW="2987324" imgH="1737170" progId="ACD.ChemSketch.20">
                  <p:embed/>
                  <p:pic>
                    <p:nvPicPr>
                      <p:cNvPr id="0" name="Object 1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2057" y="3196090"/>
                        <a:ext cx="2987675" cy="17367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Rectangle 26"/>
          <p:cNvSpPr/>
          <p:nvPr/>
        </p:nvSpPr>
        <p:spPr>
          <a:xfrm>
            <a:off x="1681526" y="4678363"/>
            <a:ext cx="15119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Beta sitostero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Rectangle 20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8746916"/>
              </p:ext>
            </p:extLst>
          </p:nvPr>
        </p:nvGraphicFramePr>
        <p:xfrm>
          <a:off x="4184619" y="3387166"/>
          <a:ext cx="3611563" cy="563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4" name="ChemSketch" r:id="rId14" imgW="3611667" imgH="563706" progId="ACD.ChemSketch.20">
                  <p:embed/>
                </p:oleObj>
              </mc:Choice>
              <mc:Fallback>
                <p:oleObj name="ChemSketch" r:id="rId14" imgW="3611667" imgH="563706" progId="ACD.ChemSketch.20">
                  <p:embed/>
                  <p:pic>
                    <p:nvPicPr>
                      <p:cNvPr id="0" name="Object 1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84619" y="3387166"/>
                        <a:ext cx="3611563" cy="56356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Rectangle 29"/>
          <p:cNvSpPr/>
          <p:nvPr/>
        </p:nvSpPr>
        <p:spPr>
          <a:xfrm>
            <a:off x="5207181" y="4064452"/>
            <a:ext cx="14093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Myristic acid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0881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6853643"/>
              </p:ext>
            </p:extLst>
          </p:nvPr>
        </p:nvGraphicFramePr>
        <p:xfrm>
          <a:off x="457200" y="1295400"/>
          <a:ext cx="2759075" cy="2103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0" name="ChemSketch" r:id="rId3" imgW="2758511" imgH="2103025" progId="ACD.ChemSketch.20">
                  <p:embed/>
                </p:oleObj>
              </mc:Choice>
              <mc:Fallback>
                <p:oleObj name="ChemSketch" r:id="rId3" imgW="2758511" imgH="2103025" progId="ACD.ChemSketch.2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7200" y="1295400"/>
                        <a:ext cx="2759075" cy="210343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752277" y="2688463"/>
            <a:ext cx="14975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>
                <a:latin typeface="Times New Roman" pitchFamily="18" charset="0"/>
                <a:cs typeface="Times New Roman" pitchFamily="18" charset="0"/>
              </a:rPr>
              <a:t>Withanolide S</a:t>
            </a:r>
          </a:p>
        </p:txBody>
      </p:sp>
      <p:sp>
        <p:nvSpPr>
          <p:cNvPr id="9" name="Rectangle 6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6033617"/>
              </p:ext>
            </p:extLst>
          </p:nvPr>
        </p:nvGraphicFramePr>
        <p:xfrm>
          <a:off x="3890185" y="1224907"/>
          <a:ext cx="2087563" cy="1341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1" name="ChemSketch" r:id="rId5" imgW="2080154" imgH="1341041" progId="ACD.ChemSketch.20">
                  <p:embed/>
                </p:oleObj>
              </mc:Choice>
              <mc:Fallback>
                <p:oleObj name="ChemSketch" r:id="rId5" imgW="2080154" imgH="1341041" progId="ACD.ChemSketch.2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90185" y="1224907"/>
                        <a:ext cx="2087563" cy="134143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Rectangle 10"/>
          <p:cNvSpPr/>
          <p:nvPr/>
        </p:nvSpPr>
        <p:spPr>
          <a:xfrm>
            <a:off x="4225944" y="2627404"/>
            <a:ext cx="11178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>
                <a:latin typeface="Times New Roman" pitchFamily="18" charset="0"/>
                <a:cs typeface="Times New Roman" pitchFamily="18" charset="0"/>
              </a:rPr>
              <a:t>Quercetin</a:t>
            </a:r>
          </a:p>
        </p:txBody>
      </p:sp>
      <p:sp>
        <p:nvSpPr>
          <p:cNvPr id="12" name="Rectangle 8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IN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6913444"/>
              </p:ext>
            </p:extLst>
          </p:nvPr>
        </p:nvGraphicFramePr>
        <p:xfrm>
          <a:off x="6651659" y="2046287"/>
          <a:ext cx="1379538" cy="601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2" name="ChemSketch" r:id="rId7" imgW="1371600" imgH="601656" progId="ACD.ChemSketch.20">
                  <p:embed/>
                </p:oleObj>
              </mc:Choice>
              <mc:Fallback>
                <p:oleObj name="ChemSketch" r:id="rId7" imgW="1371600" imgH="601656" progId="ACD.ChemSketch.2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51659" y="2046287"/>
                        <a:ext cx="1379538" cy="60166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tangle 13"/>
          <p:cNvSpPr/>
          <p:nvPr/>
        </p:nvSpPr>
        <p:spPr>
          <a:xfrm>
            <a:off x="7086600" y="2628900"/>
            <a:ext cx="15267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>
                <a:latin typeface="Times New Roman" pitchFamily="18" charset="0"/>
                <a:cs typeface="Times New Roman" pitchFamily="18" charset="0"/>
              </a:rPr>
              <a:t>Isopelletierin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971800" y="685800"/>
            <a:ext cx="3305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Identified constituents of WSA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1836737" y="3057795"/>
            <a:ext cx="5634492" cy="3544147"/>
            <a:chOff x="1836738" y="3365072"/>
            <a:chExt cx="5634037" cy="3239074"/>
          </a:xfrm>
        </p:grpSpPr>
        <p:graphicFrame>
          <p:nvGraphicFramePr>
            <p:cNvPr id="16" name="Object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97282014"/>
                </p:ext>
              </p:extLst>
            </p:nvPr>
          </p:nvGraphicFramePr>
          <p:xfrm>
            <a:off x="1836738" y="3365072"/>
            <a:ext cx="5634037" cy="28645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3" name="CS ChemDraw Drawing" r:id="rId9" imgW="3770286" imgH="2238536" progId="ChemDraw.Document.6.0">
                    <p:embed/>
                  </p:oleObj>
                </mc:Choice>
                <mc:Fallback>
                  <p:oleObj name="CS ChemDraw Drawing" r:id="rId9" imgW="3770286" imgH="2238536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836738" y="3365072"/>
                          <a:ext cx="5634037" cy="28645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3453107" y="6234814"/>
              <a:ext cx="24012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toindoside VII &amp; VIII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23012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6</Words>
  <Application>Microsoft Office PowerPoint</Application>
  <PresentationFormat>On-screen Show (4:3)</PresentationFormat>
  <Paragraphs>13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ChemSketch</vt:lpstr>
      <vt:lpstr>CS ChemDraw Drawing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rsha</dc:creator>
  <cp:lastModifiedBy>DELL</cp:lastModifiedBy>
  <cp:revision>6</cp:revision>
  <dcterms:created xsi:type="dcterms:W3CDTF">2006-08-16T00:00:00Z</dcterms:created>
  <dcterms:modified xsi:type="dcterms:W3CDTF">2021-06-09T18:50:52Z</dcterms:modified>
</cp:coreProperties>
</file>